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1"/>
    <p:restoredTop sz="94694"/>
  </p:normalViewPr>
  <p:slideViewPr>
    <p:cSldViewPr snapToGrid="0">
      <p:cViewPr varScale="1">
        <p:scale>
          <a:sx n="121" d="100"/>
          <a:sy n="121" d="100"/>
        </p:scale>
        <p:origin x="30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80FB5E7-4F3F-AAA9-1175-B8D38F45570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D5534384-5235-459F-8774-D23C5682FEE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F3E767B-8643-CA53-4490-71B4455CE5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EECDD-811C-6747-8812-D138690280B0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B2AFE3A-1F83-5847-DD6C-6AE43FD328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2798630-C7BC-2CEA-A1A1-C4BACEB005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1EA54-95C2-BF4A-B130-D0AFE9AAFF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41220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B299D9A-2AE9-C1CD-DC3D-1873D17DDD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3BA8F72-B251-10EC-8899-439EC7E980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65CE05E-07E5-D41A-638A-0F447AACDF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EECDD-811C-6747-8812-D138690280B0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3B38730-03A8-0DE3-53A4-0F152AA7C8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5B270E0-F309-F189-BFED-592E078D3C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1EA54-95C2-BF4A-B130-D0AFE9AAFF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28726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019B3733-5B5A-72D5-9E8D-4E647C4D10A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249FDE5-20C3-1C30-FCAA-795C70C86B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E83E681-29DB-F759-1BCF-5F83CF512B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EECDD-811C-6747-8812-D138690280B0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74179DF-DCEE-73D9-9E0A-963BD674FB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326705A-4893-4EA6-DB62-CE7DC3D66D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1EA54-95C2-BF4A-B130-D0AFE9AAFF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87259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FD65DC6-6A8C-22FB-D4F1-9CAF8420DE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7D3BD7F-9A0F-E1C9-EEBD-C2CD55F46EB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101D089-4076-7E95-31BC-4EBADFB2FC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EECDD-811C-6747-8812-D138690280B0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0A8678B-043A-DD91-7BB5-C5344E7109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FD68993-0009-18E6-5F03-ECC6499FDC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1EA54-95C2-BF4A-B130-D0AFE9AAFF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55968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4A459ED-1C76-12F8-0923-0846CDBDA7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7EB6284-7E74-A7F5-4C76-55FBE2FDDB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F7A1312-0811-470B-A1A6-953A72E655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EECDD-811C-6747-8812-D138690280B0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3ABCBA5-CE97-2A3B-54AE-9D6AB1139E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59F4272-73F5-CE3B-8C1D-CA415D7AE4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1EA54-95C2-BF4A-B130-D0AFE9AAFF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32775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CD39D8F-D64A-4DD4-7B27-96EAE3F29C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F2DBB51-B3A5-3EC9-2DA5-40C72CDFEB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A07F418-6EE4-2C0E-3009-BB6E2F8D68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38C22E6-E1E1-CF32-0309-D81601ED75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EECDD-811C-6747-8812-D138690280B0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9BB3762-8BF7-1166-2AC1-0A6CC25671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9806D2A-E7E9-990F-DF7F-80BEAB21AE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1EA54-95C2-BF4A-B130-D0AFE9AAFF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36454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5B4FBF9-7A6F-2EEA-30A5-B3030910E5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5776994-197B-93B7-40C5-A965DC1CA7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6423221-0D9B-8DAE-6E0D-632A799B20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B50BCE2F-3899-7E24-990F-979D4F45FFB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52C2AD28-1163-6392-7646-3FD54D216C8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F857E5B-F786-34DE-26D1-8FC3C15A43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EECDD-811C-6747-8812-D138690280B0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C3EFDF7B-635C-A3F4-2BD2-DBF5CADC8E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6427F8A3-7043-6E14-2CA8-6E5638FBA5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1EA54-95C2-BF4A-B130-D0AFE9AAFF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12452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573B335-FD6D-E9EE-2C04-AEA873761F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CBA7D2AB-E933-9388-9209-D49B9046BB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EECDD-811C-6747-8812-D138690280B0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F72BE6E-7547-0FA8-BF1F-12CB02E1C1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EC41991-6F09-372F-C9AB-6B99AC98E0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1EA54-95C2-BF4A-B130-D0AFE9AAFF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26576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E330FD6-FEF0-8051-9722-40F71131EE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EECDD-811C-6747-8812-D138690280B0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D6F478C-41D1-4A62-23C7-259917A412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17D5CB8A-AA53-FC87-D485-8894F999E2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1EA54-95C2-BF4A-B130-D0AFE9AAFF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99685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FB314A9-73B6-65A1-6EF4-967DC82408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10722DB-9DF1-1772-78C9-8DCDB042509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EA51C03-7955-AAC6-19AF-9BA089D3DE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3A849D6-0CB2-2B09-A661-B664B20BC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EECDD-811C-6747-8812-D138690280B0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D1E3EA8-CDA5-5902-4D77-A337B115EA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902A240-66FD-8C64-881E-2DA5C755D3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1EA54-95C2-BF4A-B130-D0AFE9AAFF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22458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11DCC2C-6094-0655-5C51-49A43AFE5E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B1CBF60-5CBC-CA94-732D-7D95F721A30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0AC36C3-B75A-6611-6971-B9F24F72CB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46ED346-4F96-EA86-90DF-E2CF37BBC1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EECDD-811C-6747-8812-D138690280B0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E3257DE-09FB-9F86-9AEF-60BF0D0E14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5CF7F90-12CD-0183-5870-B6CE19C119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1EA54-95C2-BF4A-B130-D0AFE9AAFF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48926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28BB5BB-9B8F-A2BE-2C3A-422427D375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E688373-C9C9-F7DE-B447-E506BCBFE2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62DD17A-1C81-3985-D681-469081ACF22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6EECDD-811C-6747-8812-D138690280B0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DB05DF5-BA2C-D1CE-F760-9C8856016D7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4338517-495E-A04B-6610-4A173BC17ED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A1EA54-95C2-BF4A-B130-D0AFE9AAFF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46506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076B5B9C-58F4-1028-74FE-2D4E34C3FF7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56482500"/>
              </p:ext>
            </p:extLst>
          </p:nvPr>
        </p:nvGraphicFramePr>
        <p:xfrm>
          <a:off x="2577052" y="2837792"/>
          <a:ext cx="6338872" cy="1938202"/>
        </p:xfrm>
        <a:graphic>
          <a:graphicData uri="http://schemas.openxmlformats.org/drawingml/2006/table">
            <a:tbl>
              <a:tblPr firstRow="1" firstCol="1" bandRow="1"/>
              <a:tblGrid>
                <a:gridCol w="905553">
                  <a:extLst>
                    <a:ext uri="{9D8B030D-6E8A-4147-A177-3AD203B41FA5}">
                      <a16:colId xmlns:a16="http://schemas.microsoft.com/office/drawing/2014/main" val="1199261974"/>
                    </a:ext>
                  </a:extLst>
                </a:gridCol>
                <a:gridCol w="476607">
                  <a:extLst>
                    <a:ext uri="{9D8B030D-6E8A-4147-A177-3AD203B41FA5}">
                      <a16:colId xmlns:a16="http://schemas.microsoft.com/office/drawing/2014/main" val="74150244"/>
                    </a:ext>
                  </a:extLst>
                </a:gridCol>
                <a:gridCol w="2049410">
                  <a:extLst>
                    <a:ext uri="{9D8B030D-6E8A-4147-A177-3AD203B41FA5}">
                      <a16:colId xmlns:a16="http://schemas.microsoft.com/office/drawing/2014/main" val="2536305617"/>
                    </a:ext>
                  </a:extLst>
                </a:gridCol>
                <a:gridCol w="2907302">
                  <a:extLst>
                    <a:ext uri="{9D8B030D-6E8A-4147-A177-3AD203B41FA5}">
                      <a16:colId xmlns:a16="http://schemas.microsoft.com/office/drawing/2014/main" val="4103352571"/>
                    </a:ext>
                  </a:extLst>
                </a:gridCol>
              </a:tblGrid>
              <a:tr h="333625">
                <a:tc>
                  <a:txBody>
                    <a:bodyPr/>
                    <a:lstStyle/>
                    <a:p>
                      <a:pPr algn="ctr"/>
                      <a:r>
                        <a:rPr lang="en-US" sz="15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Sample</a:t>
                      </a:r>
                      <a:endParaRPr lang="ja-JP" sz="13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8640" marR="7864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Sex</a:t>
                      </a:r>
                      <a:endParaRPr lang="ja-JP" sz="13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8640" marR="7864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Location of carcinoma</a:t>
                      </a:r>
                      <a:endParaRPr lang="ja-JP" sz="13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8640" marR="7864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Operation method</a:t>
                      </a:r>
                      <a:endParaRPr lang="ja-JP" sz="13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8640" marR="7864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97579216"/>
                  </a:ext>
                </a:extLst>
              </a:tr>
              <a:tr h="317738">
                <a:tc>
                  <a:txBody>
                    <a:bodyPr/>
                    <a:lstStyle/>
                    <a:p>
                      <a:pPr algn="ctr"/>
                      <a:r>
                        <a:rPr lang="en-US" sz="15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ontrol 1</a:t>
                      </a:r>
                      <a:endParaRPr lang="ja-JP" sz="13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8640" marR="7864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M</a:t>
                      </a:r>
                      <a:endParaRPr lang="ja-JP" sz="13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8640" marR="7864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Ascending colon cancer</a:t>
                      </a:r>
                      <a:endParaRPr lang="ja-JP" sz="13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8640" marR="7864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Laparoscopic right hemicolectomy</a:t>
                      </a:r>
                      <a:endParaRPr lang="ja-JP" sz="13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8640" marR="7864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22745851"/>
                  </a:ext>
                </a:extLst>
              </a:tr>
              <a:tr h="317738">
                <a:tc>
                  <a:txBody>
                    <a:bodyPr/>
                    <a:lstStyle/>
                    <a:p>
                      <a:pPr algn="ctr"/>
                      <a:r>
                        <a:rPr lang="en-US" sz="15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ontrol 2</a:t>
                      </a:r>
                      <a:endParaRPr lang="ja-JP" sz="13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8640" marR="786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F</a:t>
                      </a:r>
                      <a:endParaRPr lang="ja-JP" sz="13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8640" marR="786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ecal cancer</a:t>
                      </a:r>
                      <a:endParaRPr lang="ja-JP" sz="13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8640" marR="786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Laparoscopic right hemicolectomy</a:t>
                      </a:r>
                      <a:endParaRPr lang="ja-JP" sz="13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8640" marR="786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51249979"/>
                  </a:ext>
                </a:extLst>
              </a:tr>
              <a:tr h="317738">
                <a:tc>
                  <a:txBody>
                    <a:bodyPr/>
                    <a:lstStyle/>
                    <a:p>
                      <a:pPr algn="ctr"/>
                      <a:r>
                        <a:rPr lang="en-US" sz="15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ontrol 3</a:t>
                      </a:r>
                      <a:endParaRPr lang="ja-JP" sz="13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8640" marR="786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M</a:t>
                      </a:r>
                      <a:endParaRPr lang="ja-JP" sz="13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8640" marR="786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Ascending colon cancer</a:t>
                      </a:r>
                      <a:endParaRPr lang="ja-JP" sz="13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8640" marR="786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Laparoscopic right hemicolectomy</a:t>
                      </a:r>
                      <a:endParaRPr lang="ja-JP" sz="13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8640" marR="786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44541965"/>
                  </a:ext>
                </a:extLst>
              </a:tr>
              <a:tr h="317738">
                <a:tc>
                  <a:txBody>
                    <a:bodyPr/>
                    <a:lstStyle/>
                    <a:p>
                      <a:pPr algn="ctr"/>
                      <a:r>
                        <a:rPr lang="en-US" sz="15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ontrol 4</a:t>
                      </a:r>
                      <a:endParaRPr lang="ja-JP" sz="13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8640" marR="786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F</a:t>
                      </a:r>
                      <a:endParaRPr lang="ja-JP" sz="13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8640" marR="786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Ascending colon cancer</a:t>
                      </a:r>
                      <a:endParaRPr lang="ja-JP" sz="13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8640" marR="786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Robot-assisted ileocecal resection</a:t>
                      </a:r>
                      <a:endParaRPr lang="ja-JP" sz="13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8640" marR="786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42373711"/>
                  </a:ext>
                </a:extLst>
              </a:tr>
              <a:tr h="333625">
                <a:tc>
                  <a:txBody>
                    <a:bodyPr/>
                    <a:lstStyle/>
                    <a:p>
                      <a:pPr algn="ctr"/>
                      <a:r>
                        <a:rPr lang="en-US" sz="15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ontrol 5</a:t>
                      </a:r>
                      <a:endParaRPr lang="ja-JP" sz="13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8640" marR="786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F</a:t>
                      </a:r>
                      <a:endParaRPr lang="ja-JP" sz="13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8640" marR="786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Ascending colon cancer</a:t>
                      </a:r>
                      <a:endParaRPr lang="ja-JP" sz="13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8640" marR="786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Laparoscopic right hemicolectomy</a:t>
                      </a:r>
                      <a:endParaRPr lang="ja-JP" sz="13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8640" marR="786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1050152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818801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1</Words>
  <Application>Microsoft Macintosh PowerPoint</Application>
  <PresentationFormat>ワイド画面</PresentationFormat>
  <Paragraphs>2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游明朝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梨紗 中西</dc:creator>
  <cp:lastModifiedBy>梨紗 中西</cp:lastModifiedBy>
  <cp:revision>3</cp:revision>
  <dcterms:created xsi:type="dcterms:W3CDTF">2024-06-18T01:53:30Z</dcterms:created>
  <dcterms:modified xsi:type="dcterms:W3CDTF">2024-07-06T09:12:49Z</dcterms:modified>
</cp:coreProperties>
</file>